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99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2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999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4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14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26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5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03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8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46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13A93-730C-4283-AF03-8B4AB0941595}" type="datetimeFigureOut">
              <a:rPr kumimoji="1" lang="ja-JP" altLang="en-US" smtClean="0"/>
              <a:t>2023/3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7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093C4AA7-0E9A-4842-B1FB-9449D20FD16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48068"/>
            <a:ext cx="6858000" cy="1812823"/>
          </a:xfrm>
          <a:prstGeom prst="rect">
            <a:avLst/>
          </a:prstGeom>
        </p:spPr>
      </p:pic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A156556E-C7AA-44CC-82A2-3117AA5A10EC}"/>
              </a:ext>
            </a:extLst>
          </p:cNvPr>
          <p:cNvSpPr/>
          <p:nvPr/>
        </p:nvSpPr>
        <p:spPr>
          <a:xfrm>
            <a:off x="0" y="136980"/>
            <a:ext cx="68580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able S3</a:t>
            </a: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Bronchoalveolar lavage fluid (BALF) counts in mice infected with M019 and treated with chemotherapy</a:t>
            </a:r>
            <a:endParaRPr lang="ja-JP" altLang="ja-JP" sz="1400" kern="100" dirty="0">
              <a:effectLst/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43212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20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eishi</dc:creator>
  <cp:lastModifiedBy>Tateishi</cp:lastModifiedBy>
  <cp:revision>13</cp:revision>
  <dcterms:created xsi:type="dcterms:W3CDTF">2022-12-07T03:50:42Z</dcterms:created>
  <dcterms:modified xsi:type="dcterms:W3CDTF">2023-03-09T05:00:44Z</dcterms:modified>
</cp:coreProperties>
</file>